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1863C-15F6-4054-88AB-1686DE1AC0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3D5531-18FD-4DA1-8666-4CB8AC35DB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C94F26-3A75-40FC-8512-BB8E233B7A7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7ECCF0-E0A0-40ED-BFB0-30C252DE43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B6451-BD51-463B-A43A-22D8172365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CABAB-69F1-4A87-B447-099077DC78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E2055A-5F71-4226-8477-6C17C32406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CB475E-E937-4F2A-843A-3E9B045A12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AAB664-1139-47AD-879C-687D3C4F40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4CB243-2B99-45FD-BBA1-ABE3936632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676F53-97B4-4193-A1E1-4307E5CABF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317B5-16F0-42B7-B791-7C84493605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8769B6-AB55-48B5-A8D4-7102210431EF}" type="slidenum"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4515840" y="536400"/>
            <a:ext cx="1476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CA" sz="800" spc="-1" strike="noStrike">
                <a:solidFill>
                  <a:srgbClr val="000000"/>
                </a:solidFill>
                <a:latin typeface="Arial"/>
              </a:rPr>
              <a:t>Lasiurus-</a:t>
            </a: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associated varian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3"/>
          <p:cNvSpPr/>
          <p:nvPr/>
        </p:nvSpPr>
        <p:spPr>
          <a:xfrm>
            <a:off x="4646520" y="90360"/>
            <a:ext cx="1658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Silver-haired and tri-coloured b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variant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4"/>
          <p:cNvSpPr/>
          <p:nvPr/>
        </p:nvSpPr>
        <p:spPr>
          <a:xfrm>
            <a:off x="4596120" y="816120"/>
            <a:ext cx="1681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CA" sz="800" spc="-1" strike="noStrike">
                <a:solidFill>
                  <a:srgbClr val="000000"/>
                </a:solidFill>
                <a:latin typeface="Arial"/>
              </a:rPr>
              <a:t>Nyctinomops</a:t>
            </a: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-associated varian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5"/>
          <p:cNvSpPr/>
          <p:nvPr/>
        </p:nvSpPr>
        <p:spPr>
          <a:xfrm>
            <a:off x="4233960" y="1068480"/>
            <a:ext cx="1483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CA" sz="800" spc="-1" strike="noStrike">
                <a:solidFill>
                  <a:srgbClr val="000000"/>
                </a:solidFill>
                <a:latin typeface="Arial"/>
              </a:rPr>
              <a:t>Histiotus</a:t>
            </a: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-associated varian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6"/>
          <p:cNvSpPr/>
          <p:nvPr/>
        </p:nvSpPr>
        <p:spPr>
          <a:xfrm>
            <a:off x="4411440" y="1444680"/>
            <a:ext cx="62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LL varia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7"/>
          <p:cNvSpPr/>
          <p:nvPr/>
        </p:nvSpPr>
        <p:spPr>
          <a:xfrm>
            <a:off x="4312080" y="1733400"/>
            <a:ext cx="1151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NA EF-WEST grou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8"/>
          <p:cNvSpPr/>
          <p:nvPr/>
        </p:nvSpPr>
        <p:spPr>
          <a:xfrm>
            <a:off x="4223520" y="2371680"/>
            <a:ext cx="49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US-Y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9"/>
          <p:cNvSpPr/>
          <p:nvPr/>
        </p:nvSpPr>
        <p:spPr>
          <a:xfrm>
            <a:off x="4313520" y="2751120"/>
            <a:ext cx="216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SA </a:t>
            </a:r>
            <a:r>
              <a:rPr b="0" i="1" lang="en-CA" sz="800" spc="-1" strike="noStrike">
                <a:solidFill>
                  <a:srgbClr val="000000"/>
                </a:solidFill>
                <a:latin typeface="Arial"/>
              </a:rPr>
              <a:t>Tadarida braziliensis–associated varia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0"/>
          <p:cNvSpPr/>
          <p:nvPr/>
        </p:nvSpPr>
        <p:spPr>
          <a:xfrm>
            <a:off x="4294080" y="2886120"/>
            <a:ext cx="1471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CA" sz="800" spc="-1" strike="noStrike">
                <a:solidFill>
                  <a:srgbClr val="000000"/>
                </a:solidFill>
                <a:latin typeface="Arial"/>
              </a:rPr>
              <a:t>Molossus-associated varia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1"/>
          <p:cNvSpPr/>
          <p:nvPr/>
        </p:nvSpPr>
        <p:spPr>
          <a:xfrm>
            <a:off x="4308480" y="3076560"/>
            <a:ext cx="208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SA </a:t>
            </a:r>
            <a:r>
              <a:rPr b="0" i="1" lang="en-CA" sz="800" spc="-1" strike="noStrike">
                <a:solidFill>
                  <a:srgbClr val="000000"/>
                </a:solidFill>
                <a:latin typeface="Arial"/>
              </a:rPr>
              <a:t>Eptesicus furinalis</a:t>
            </a: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-associated varian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2"/>
          <p:cNvSpPr/>
          <p:nvPr/>
        </p:nvSpPr>
        <p:spPr>
          <a:xfrm>
            <a:off x="4288320" y="3332160"/>
            <a:ext cx="214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NA </a:t>
            </a:r>
            <a:r>
              <a:rPr b="0" i="1" lang="en-CA" sz="800" spc="-1" strike="noStrike">
                <a:solidFill>
                  <a:srgbClr val="000000"/>
                </a:solidFill>
                <a:latin typeface="Arial"/>
              </a:rPr>
              <a:t>Tadarida braziliensis-associated varia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3"/>
          <p:cNvSpPr/>
          <p:nvPr/>
        </p:nvSpPr>
        <p:spPr>
          <a:xfrm>
            <a:off x="4616280" y="4211640"/>
            <a:ext cx="1837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MYSA – heterogenous group of viruses associated with </a:t>
            </a:r>
            <a:r>
              <a:rPr b="0" i="1" lang="en-CA" sz="800" spc="-1" strike="noStrike">
                <a:solidFill>
                  <a:srgbClr val="000000"/>
                </a:solidFill>
                <a:latin typeface="Arial"/>
              </a:rPr>
              <a:t>Myotis</a:t>
            </a: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 bats of South Ameri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4"/>
          <p:cNvSpPr/>
          <p:nvPr/>
        </p:nvSpPr>
        <p:spPr>
          <a:xfrm>
            <a:off x="5232960" y="6492960"/>
            <a:ext cx="476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MY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5"/>
          <p:cNvSpPr/>
          <p:nvPr/>
        </p:nvSpPr>
        <p:spPr>
          <a:xfrm>
            <a:off x="4214880" y="8713800"/>
            <a:ext cx="640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US EF-E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6"/>
          <p:cNvSpPr/>
          <p:nvPr/>
        </p:nvSpPr>
        <p:spPr>
          <a:xfrm>
            <a:off x="4222800" y="8497800"/>
            <a:ext cx="2006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US AUS2 / Pallid bat–associated varia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4656"/>
          <p:cNvSpPr/>
          <p:nvPr/>
        </p:nvSpPr>
        <p:spPr>
          <a:xfrm>
            <a:off x="4313880" y="6657840"/>
            <a:ext cx="54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MYC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Straight Connector 2"/>
          <p:cNvSpPr/>
          <p:nvPr/>
        </p:nvSpPr>
        <p:spPr>
          <a:xfrm>
            <a:off x="4075200" y="5972040"/>
            <a:ext cx="0" cy="2487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Straight Connector 4"/>
          <p:cNvSpPr/>
          <p:nvPr/>
        </p:nvSpPr>
        <p:spPr>
          <a:xfrm>
            <a:off x="4960800" y="5567400"/>
            <a:ext cx="0" cy="288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9" name="Straight Arrow Connector 6"/>
          <p:cNvCxnSpPr/>
          <p:nvPr/>
        </p:nvCxnSpPr>
        <p:spPr>
          <a:xfrm flipH="1">
            <a:off x="3484440" y="8598960"/>
            <a:ext cx="603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0" name="Straight Arrow Connector 595"/>
          <p:cNvCxnSpPr/>
          <p:nvPr/>
        </p:nvCxnSpPr>
        <p:spPr>
          <a:xfrm flipH="1">
            <a:off x="3510000" y="8762760"/>
            <a:ext cx="603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1" name="Straight Connector 8"/>
          <p:cNvSpPr/>
          <p:nvPr/>
        </p:nvSpPr>
        <p:spPr>
          <a:xfrm flipH="1">
            <a:off x="4435560" y="3600360"/>
            <a:ext cx="9360" cy="1562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10"/>
          <p:cNvSpPr/>
          <p:nvPr/>
        </p:nvSpPr>
        <p:spPr>
          <a:xfrm flipH="1">
            <a:off x="4106880" y="3070080"/>
            <a:ext cx="1440" cy="293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3" name="Straight Arrow Connector 12"/>
          <p:cNvCxnSpPr/>
          <p:nvPr/>
        </p:nvCxnSpPr>
        <p:spPr>
          <a:xfrm flipH="1" flipV="1">
            <a:off x="3843000" y="2975760"/>
            <a:ext cx="419760" cy="5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4" name="Straight Arrow Connector 602"/>
          <p:cNvCxnSpPr/>
          <p:nvPr/>
        </p:nvCxnSpPr>
        <p:spPr>
          <a:xfrm flipH="1" flipV="1">
            <a:off x="3879360" y="2861640"/>
            <a:ext cx="386640" cy="3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5" name="Straight Connector 14"/>
          <p:cNvSpPr/>
          <p:nvPr/>
        </p:nvSpPr>
        <p:spPr>
          <a:xfrm>
            <a:off x="4092480" y="2254320"/>
            <a:ext cx="0" cy="495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6" name="Straight Arrow Connector 605"/>
          <p:cNvCxnSpPr/>
          <p:nvPr/>
        </p:nvCxnSpPr>
        <p:spPr>
          <a:xfrm flipH="1" flipV="1">
            <a:off x="3940920" y="1557000"/>
            <a:ext cx="4150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7" name="Straight Arrow Connector 606"/>
          <p:cNvCxnSpPr/>
          <p:nvPr/>
        </p:nvCxnSpPr>
        <p:spPr>
          <a:xfrm flipH="1">
            <a:off x="4147560" y="923400"/>
            <a:ext cx="4165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8" name="Straight Connector 20"/>
          <p:cNvSpPr/>
          <p:nvPr/>
        </p:nvSpPr>
        <p:spPr>
          <a:xfrm>
            <a:off x="4108320" y="1077840"/>
            <a:ext cx="0" cy="217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22"/>
          <p:cNvSpPr/>
          <p:nvPr/>
        </p:nvSpPr>
        <p:spPr>
          <a:xfrm flipH="1">
            <a:off x="4443480" y="361800"/>
            <a:ext cx="1440" cy="417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0" name="Straight Arrow Connector 615"/>
          <p:cNvCxnSpPr/>
          <p:nvPr/>
        </p:nvCxnSpPr>
        <p:spPr>
          <a:xfrm flipH="1" flipV="1">
            <a:off x="4242960" y="192960"/>
            <a:ext cx="3801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1" name="Straight Connector 29"/>
          <p:cNvSpPr/>
          <p:nvPr/>
        </p:nvSpPr>
        <p:spPr>
          <a:xfrm>
            <a:off x="4087800" y="1641600"/>
            <a:ext cx="0" cy="371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2" name="Straight Arrow Connector 2048"/>
          <p:cNvCxnSpPr/>
          <p:nvPr/>
        </p:nvCxnSpPr>
        <p:spPr>
          <a:xfrm flipH="1">
            <a:off x="3706200" y="2103120"/>
            <a:ext cx="4100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3" name="TextBox 575"/>
          <p:cNvSpPr/>
          <p:nvPr/>
        </p:nvSpPr>
        <p:spPr>
          <a:xfrm>
            <a:off x="4129200" y="1998720"/>
            <a:ext cx="243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Distinct branch of Myotis-associated variants (AZ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4" name="Straight Arrow Connector 587"/>
          <p:cNvCxnSpPr/>
          <p:nvPr/>
        </p:nvCxnSpPr>
        <p:spPr>
          <a:xfrm flipH="1">
            <a:off x="4135320" y="5214600"/>
            <a:ext cx="362520" cy="3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5" name="TextBox 588"/>
          <p:cNvSpPr/>
          <p:nvPr/>
        </p:nvSpPr>
        <p:spPr>
          <a:xfrm>
            <a:off x="4525920" y="5126040"/>
            <a:ext cx="66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US EF-E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6" name="Straight Arrow Connector 642"/>
          <p:cNvCxnSpPr/>
          <p:nvPr/>
        </p:nvCxnSpPr>
        <p:spPr>
          <a:xfrm flipH="1">
            <a:off x="4119480" y="5443560"/>
            <a:ext cx="3625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7" name="TextBox 591"/>
          <p:cNvSpPr/>
          <p:nvPr/>
        </p:nvSpPr>
        <p:spPr>
          <a:xfrm>
            <a:off x="4527000" y="5321160"/>
            <a:ext cx="198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CA" sz="800" spc="-1" strike="noStrike">
                <a:solidFill>
                  <a:srgbClr val="000000"/>
                </a:solidFill>
                <a:latin typeface="Arial"/>
              </a:rPr>
              <a:t>Pipistrellus hesperus</a:t>
            </a: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-associated varia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Picture 591" descr=""/>
          <p:cNvPicPr/>
          <p:nvPr/>
        </p:nvPicPr>
        <p:blipFill>
          <a:blip r:embed="rId1"/>
          <a:stretch/>
        </p:blipFill>
        <p:spPr>
          <a:xfrm>
            <a:off x="1447920" y="103320"/>
            <a:ext cx="2463840" cy="9040680"/>
          </a:xfrm>
          <a:prstGeom prst="rect">
            <a:avLst/>
          </a:prstGeom>
          <a:ln w="0">
            <a:noFill/>
          </a:ln>
        </p:spPr>
      </p:pic>
      <p:sp>
        <p:nvSpPr>
          <p:cNvPr id="79" name="TextBox 1"/>
          <p:cNvSpPr/>
          <p:nvPr/>
        </p:nvSpPr>
        <p:spPr>
          <a:xfrm>
            <a:off x="3972240" y="5724360"/>
            <a:ext cx="61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US AUS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0" name="Straight Arrow Connector 41"/>
          <p:cNvCxnSpPr/>
          <p:nvPr/>
        </p:nvCxnSpPr>
        <p:spPr>
          <a:xfrm flipH="1">
            <a:off x="3547440" y="5827320"/>
            <a:ext cx="36252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2-10-27T21:25:29Z</dcterms:created>
  <dc:creator>Elizabeth Loza Rubio</dc:creator>
  <dc:description/>
  <dc:language>en-US</dc:language>
  <cp:lastModifiedBy>Susan Nadon-Davis</cp:lastModifiedBy>
  <cp:lastPrinted>2014-03-05T21:42:37Z</cp:lastPrinted>
  <dcterms:modified xsi:type="dcterms:W3CDTF">2017-03-12T16:34:27Z</dcterms:modified>
  <cp:revision>84</cp:revision>
  <dc:subject/>
  <dc:title>Presentación de PowerPoint</dc:title>
</cp:coreProperties>
</file>